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-1284" y="-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ציור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438E1-117D-44FB-AC24-B79D899BA877}" type="datetimeFigureOut">
              <a:rPr lang="he-IL" smtClean="0"/>
              <a:t>י"ט/חשון/תשפ"ד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22AC9-109E-4E4D-92F9-530E51D9A3A2}" type="slidenum">
              <a:rPr lang="he-IL" smtClean="0"/>
              <a:t>‹#›</a:t>
            </a:fld>
            <a:endParaRPr lang="he-I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laptops backup\Abhishek Projects\1_Projects\NK cell biology project\Anergy\August 2021\WB - A and R\24 Aug 21_pNK A&amp;R GAPDH 5s 2021.08.24_16.42.09_Ch\24 Aug 21_pNK A&amp;R GAPDH 5s 2021.08.24_16.42.09_Ch+Marker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884" r="4081" b="57038"/>
          <a:stretch/>
        </p:blipFill>
        <p:spPr bwMode="auto">
          <a:xfrm>
            <a:off x="2267744" y="2564904"/>
            <a:ext cx="3828481" cy="9462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laptops backup\Abhishek Projects\1_Projects\NK cell biology project\Anergy\August 2021\WB - A and R\24 Aug 21_pNK A&amp;R DGKa 10s 2021.08.24_17.14.30_Ch\24 Aug 21_pNK A&amp;R DGKa 10s 2021.08.24_17.14.30_Ch+Marker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7" t="11875" b="69123"/>
          <a:stretch/>
        </p:blipFill>
        <p:spPr bwMode="auto">
          <a:xfrm>
            <a:off x="2267744" y="1785752"/>
            <a:ext cx="3828481" cy="7791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4221126" y="1785752"/>
            <a:ext cx="1214970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4243381" y="1412776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684397" y="1421520"/>
            <a:ext cx="26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001497" y="142323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123158" y="2564903"/>
            <a:ext cx="2228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rtl="0"/>
            <a:r>
              <a:rPr lang="en-US" dirty="0"/>
              <a:t>IB:M</a:t>
            </a:r>
            <a:r>
              <a:rPr lang="el-GR" dirty="0"/>
              <a:t>α</a:t>
            </a:r>
            <a:r>
              <a:rPr lang="en-US" dirty="0" smtClean="0"/>
              <a:t>GAPDH (37kDa)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056650" y="1709098"/>
            <a:ext cx="20120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rtl="0"/>
            <a:r>
              <a:rPr lang="en-US" dirty="0"/>
              <a:t>IB:R</a:t>
            </a:r>
            <a:r>
              <a:rPr lang="el-GR" dirty="0"/>
              <a:t>α</a:t>
            </a:r>
            <a:r>
              <a:rPr lang="en-US" dirty="0"/>
              <a:t>DGK</a:t>
            </a:r>
            <a:r>
              <a:rPr lang="el-GR" dirty="0" smtClean="0"/>
              <a:t>α </a:t>
            </a:r>
            <a:r>
              <a:rPr lang="en-US" dirty="0" smtClean="0"/>
              <a:t>(83kDa)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195313" y="3540212"/>
            <a:ext cx="230390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rtl="0"/>
            <a:r>
              <a:rPr lang="en-US" dirty="0"/>
              <a:t>1 – </a:t>
            </a:r>
            <a:r>
              <a:rPr lang="en-US" dirty="0" err="1"/>
              <a:t>Anergic</a:t>
            </a:r>
            <a:r>
              <a:rPr lang="en-US" dirty="0"/>
              <a:t> NS</a:t>
            </a:r>
          </a:p>
          <a:p>
            <a:pPr algn="l" rtl="0"/>
            <a:r>
              <a:rPr lang="en-US" dirty="0"/>
              <a:t>2 – </a:t>
            </a:r>
            <a:r>
              <a:rPr lang="en-US" dirty="0" err="1"/>
              <a:t>Anergic</a:t>
            </a:r>
            <a:r>
              <a:rPr lang="en-US" dirty="0"/>
              <a:t> siRNA Egr2</a:t>
            </a:r>
          </a:p>
          <a:p>
            <a:pPr algn="l" rtl="0"/>
            <a:r>
              <a:rPr lang="en-US" dirty="0"/>
              <a:t>3 – Responsive N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056650" y="1970418"/>
            <a:ext cx="1890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rtl="0"/>
            <a:r>
              <a:rPr lang="en-US" dirty="0"/>
              <a:t>IB:R</a:t>
            </a:r>
            <a:r>
              <a:rPr lang="el-GR" dirty="0"/>
              <a:t>α</a:t>
            </a:r>
            <a:r>
              <a:rPr lang="en-US" dirty="0" smtClean="0"/>
              <a:t>Egr2 (55kDa)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4221126" y="1988840"/>
            <a:ext cx="1214970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4211960" y="2564904"/>
            <a:ext cx="1214970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3575467" y="1035099"/>
            <a:ext cx="11767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/>
              <a:t>Figure </a:t>
            </a:r>
            <a:r>
              <a:rPr lang="en-US" sz="2000" smtClean="0"/>
              <a:t>4D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932824034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של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9</TotalTime>
  <Words>37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ערכת נושא של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wUser</dc:creator>
  <cp:lastModifiedBy>MBS</cp:lastModifiedBy>
  <cp:revision>28</cp:revision>
  <dcterms:created xsi:type="dcterms:W3CDTF">2021-08-24T14:26:07Z</dcterms:created>
  <dcterms:modified xsi:type="dcterms:W3CDTF">2023-11-03T13:12:48Z</dcterms:modified>
</cp:coreProperties>
</file>